
<file path=[Content_Types].xml><?xml version="1.0" encoding="utf-8"?>
<Types xmlns="http://schemas.openxmlformats.org/package/2006/content-types">
  <Default Extension="emf" ContentType="image/x-emf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 horzBarState="maximized">
    <p:restoredLeft sz="15620"/>
    <p:restoredTop sz="94660"/>
  </p:normalViewPr>
  <p:slideViewPr>
    <p:cSldViewPr>
      <p:cViewPr>
        <p:scale>
          <a:sx n="150" d="100"/>
          <a:sy n="150" d="100"/>
        </p:scale>
        <p:origin x="-2216" y="164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687240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766632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227432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5452652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08566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022639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444737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753317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9744582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763737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407772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7F11AC-F3C3-4DD5-85B7-93E1159D8BAD}" type="datetimeFigureOut">
              <a:rPr lang="en-CA" smtClean="0"/>
              <a:pPr/>
              <a:t>7/8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738127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817531" y="297078"/>
            <a:ext cx="5354574" cy="5151499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Text Box 2"/>
          <p:cNvSpPr txBox="1">
            <a:spLocks noChangeArrowheads="1"/>
          </p:cNvSpPr>
          <p:nvPr/>
        </p:nvSpPr>
        <p:spPr bwMode="auto">
          <a:xfrm>
            <a:off x="1009895" y="478754"/>
            <a:ext cx="793811" cy="406334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CA" sz="1200">
                <a:effectLst/>
                <a:latin typeface="Times New Roman"/>
                <a:ea typeface="Calibri"/>
                <a:cs typeface="Times New Roman"/>
              </a:rPr>
              <a:t>Cluster 6</a:t>
            </a:r>
            <a:endParaRPr lang="en-CA" sz="1100">
              <a:effectLst/>
              <a:latin typeface="Calibri"/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CA" sz="1200">
                <a:effectLst/>
                <a:latin typeface="Times New Roman"/>
                <a:ea typeface="Calibri"/>
                <a:cs typeface="Times New Roman"/>
              </a:rPr>
              <a:t>Class V</a:t>
            </a:r>
            <a:endParaRPr lang="en-CA" sz="110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8" name="Text Box 2"/>
          <p:cNvSpPr txBox="1">
            <a:spLocks noChangeArrowheads="1"/>
          </p:cNvSpPr>
          <p:nvPr/>
        </p:nvSpPr>
        <p:spPr bwMode="auto">
          <a:xfrm>
            <a:off x="5167363" y="339819"/>
            <a:ext cx="928685" cy="406334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CA" sz="1200">
                <a:effectLst/>
                <a:latin typeface="Times New Roman"/>
                <a:ea typeface="Calibri"/>
                <a:cs typeface="Times New Roman"/>
              </a:rPr>
              <a:t>Cluster 1 </a:t>
            </a:r>
            <a:endParaRPr lang="en-CA" sz="1100">
              <a:effectLst/>
              <a:latin typeface="Calibri"/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CA" sz="1200">
                <a:effectLst/>
                <a:latin typeface="Times New Roman"/>
                <a:ea typeface="Calibri"/>
                <a:cs typeface="Times New Roman"/>
              </a:rPr>
              <a:t>Class IV</a:t>
            </a:r>
            <a:endParaRPr lang="en-CA" sz="110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9" name="Text Box 2"/>
          <p:cNvSpPr txBox="1">
            <a:spLocks noChangeArrowheads="1"/>
          </p:cNvSpPr>
          <p:nvPr/>
        </p:nvSpPr>
        <p:spPr bwMode="auto">
          <a:xfrm>
            <a:off x="144202" y="3578032"/>
            <a:ext cx="793811" cy="406334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CA" sz="1200">
                <a:effectLst/>
                <a:latin typeface="Times New Roman"/>
                <a:ea typeface="Calibri"/>
                <a:cs typeface="Times New Roman"/>
              </a:rPr>
              <a:t>Cluster 4 </a:t>
            </a:r>
            <a:endParaRPr lang="en-CA" sz="1100">
              <a:effectLst/>
              <a:latin typeface="Calibri"/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CA" sz="1200">
                <a:effectLst/>
                <a:latin typeface="Times New Roman"/>
                <a:ea typeface="Calibri"/>
                <a:cs typeface="Times New Roman"/>
              </a:rPr>
              <a:t>Class  II</a:t>
            </a:r>
            <a:endParaRPr lang="en-CA" sz="110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0" name="Text Box 2"/>
          <p:cNvSpPr txBox="1">
            <a:spLocks noChangeArrowheads="1"/>
          </p:cNvSpPr>
          <p:nvPr/>
        </p:nvSpPr>
        <p:spPr bwMode="auto">
          <a:xfrm>
            <a:off x="2249655" y="5491036"/>
            <a:ext cx="901177" cy="517065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CA" sz="1200" dirty="0">
                <a:effectLst/>
                <a:latin typeface="Times New Roman"/>
                <a:ea typeface="Calibri"/>
                <a:cs typeface="Times New Roman"/>
              </a:rPr>
              <a:t>Cluster 3 </a:t>
            </a:r>
            <a:endParaRPr lang="en-CA" sz="1100" dirty="0">
              <a:effectLst/>
              <a:latin typeface="Calibri"/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CA" sz="1200" dirty="0">
                <a:effectLst/>
                <a:latin typeface="Times New Roman"/>
                <a:ea typeface="Calibri"/>
                <a:cs typeface="Times New Roman"/>
              </a:rPr>
              <a:t>Class I - II</a:t>
            </a:r>
            <a:endParaRPr lang="en-CA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1" name="Text Box 2"/>
          <p:cNvSpPr txBox="1">
            <a:spLocks noChangeArrowheads="1"/>
          </p:cNvSpPr>
          <p:nvPr/>
        </p:nvSpPr>
        <p:spPr bwMode="auto">
          <a:xfrm>
            <a:off x="122826" y="2039080"/>
            <a:ext cx="793811" cy="406334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CA" sz="1200" dirty="0">
                <a:effectLst/>
                <a:latin typeface="Times New Roman"/>
                <a:ea typeface="Calibri"/>
                <a:cs typeface="Times New Roman"/>
              </a:rPr>
              <a:t>Cluster 5 </a:t>
            </a:r>
            <a:endParaRPr lang="en-CA" sz="1100" dirty="0">
              <a:effectLst/>
              <a:latin typeface="Calibri"/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CA" sz="1200" dirty="0">
                <a:effectLst/>
                <a:latin typeface="Times New Roman"/>
                <a:ea typeface="Calibri"/>
                <a:cs typeface="Times New Roman"/>
              </a:rPr>
              <a:t>Class III</a:t>
            </a:r>
            <a:endParaRPr lang="en-CA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2" name="Text Box 2"/>
          <p:cNvSpPr txBox="1">
            <a:spLocks noChangeArrowheads="1"/>
          </p:cNvSpPr>
          <p:nvPr/>
        </p:nvSpPr>
        <p:spPr bwMode="auto">
          <a:xfrm>
            <a:off x="5947557" y="3845402"/>
            <a:ext cx="793811" cy="406334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CA" sz="1200">
                <a:effectLst/>
                <a:latin typeface="Times New Roman"/>
                <a:ea typeface="Calibri"/>
                <a:cs typeface="Times New Roman"/>
              </a:rPr>
              <a:t>Cluster 2 </a:t>
            </a:r>
            <a:endParaRPr lang="en-CA" sz="1100">
              <a:effectLst/>
              <a:latin typeface="Calibri"/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CA" sz="1200">
                <a:effectLst/>
                <a:latin typeface="Times New Roman"/>
                <a:ea typeface="Calibri"/>
                <a:cs typeface="Times New Roman"/>
              </a:rPr>
              <a:t>Class II</a:t>
            </a:r>
            <a:endParaRPr lang="en-CA" sz="110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3" name="Donut 12"/>
          <p:cNvSpPr/>
          <p:nvPr/>
        </p:nvSpPr>
        <p:spPr>
          <a:xfrm>
            <a:off x="838907" y="179512"/>
            <a:ext cx="5345989" cy="5345983"/>
          </a:xfrm>
          <a:prstGeom prst="donu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CA"/>
          </a:p>
        </p:txBody>
      </p:sp>
      <p:cxnSp>
        <p:nvCxnSpPr>
          <p:cNvPr id="14" name="Straight Connector 13"/>
          <p:cNvCxnSpPr/>
          <p:nvPr/>
        </p:nvCxnSpPr>
        <p:spPr>
          <a:xfrm flipV="1">
            <a:off x="4739943" y="1782676"/>
            <a:ext cx="1231009" cy="531493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4216243" y="3984354"/>
            <a:ext cx="726375" cy="1101277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H="1">
            <a:off x="1223667" y="3514093"/>
            <a:ext cx="1117852" cy="727264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>
            <a:off x="849594" y="2969017"/>
            <a:ext cx="1336736" cy="113728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H="1" flipV="1">
            <a:off x="3061964" y="232951"/>
            <a:ext cx="177736" cy="1295996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H="1">
            <a:off x="5167454" y="1087972"/>
            <a:ext cx="220093" cy="201739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 flipH="1" flipV="1">
            <a:off x="4301745" y="4956940"/>
            <a:ext cx="119536" cy="256031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 flipV="1">
            <a:off x="3767356" y="5085193"/>
            <a:ext cx="0" cy="256031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 flipV="1">
            <a:off x="1929059" y="4668371"/>
            <a:ext cx="136894" cy="191385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 flipH="1" flipV="1">
            <a:off x="1074038" y="1750613"/>
            <a:ext cx="1193197" cy="583198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Rectangle 3"/>
          <p:cNvSpPr/>
          <p:nvPr/>
        </p:nvSpPr>
        <p:spPr>
          <a:xfrm>
            <a:off x="541107" y="6588224"/>
            <a:ext cx="5962972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Supplemental Fig. S6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Topology of reference </a:t>
            </a:r>
            <a:r>
              <a:rPr lang="en-CA" sz="1200" dirty="0" err="1">
                <a:latin typeface="Times New Roman" pitchFamily="18" charset="0"/>
                <a:cs typeface="Times New Roman" pitchFamily="18" charset="0"/>
              </a:rPr>
              <a:t>chitinase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 proteins and putative </a:t>
            </a:r>
            <a:r>
              <a:rPr lang="en-CA" sz="1200" dirty="0" err="1">
                <a:latin typeface="Times New Roman" pitchFamily="18" charset="0"/>
                <a:cs typeface="Times New Roman" pitchFamily="18" charset="0"/>
              </a:rPr>
              <a:t>chitinase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 proteins derived from EST sequences from jack and </a:t>
            </a:r>
            <a:r>
              <a:rPr lang="en-CA" sz="1200" dirty="0" err="1">
                <a:latin typeface="Times New Roman" pitchFamily="18" charset="0"/>
                <a:cs typeface="Times New Roman" pitchFamily="18" charset="0"/>
              </a:rPr>
              <a:t>lodgepole</a:t>
            </a:r>
            <a:r>
              <a:rPr lang="en-CA" sz="1200" dirty="0">
                <a:latin typeface="Times New Roman" pitchFamily="18" charset="0"/>
                <a:cs typeface="Times New Roman" pitchFamily="18" charset="0"/>
              </a:rPr>
              <a:t> pine. Genes pointed by arrows were investigated by RT-PCR. Relationships were estimated using the Neighbor Joining method and the consensus tree was inferred from 1000 bootstrap replicates. Bootstrap values are shown for each branch. 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Pc –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Pinus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contorta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Pb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–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Pinus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banksiana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, Pm –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Picea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mariana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Pg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–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Picea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glauca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, Pa –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Pice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abies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, At –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Arabiodpsis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thaliana,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Gh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–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Gossypium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hirsutum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, St –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Solanum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tuberosum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Sc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–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Secale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cereal,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Zm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–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Zea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mays,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Hv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–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Hordeum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vulgare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Nt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–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Nicotiana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tabaccum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Os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–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Oryza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sativa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Sr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–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Sesbania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rostrata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Ms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–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Medicago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i="1" dirty="0" err="1">
                <a:latin typeface="Times New Roman" pitchFamily="18" charset="0"/>
                <a:cs typeface="Times New Roman" pitchFamily="18" charset="0"/>
              </a:rPr>
              <a:t>sativa</a:t>
            </a:r>
            <a:r>
              <a:rPr lang="en-CA" sz="1200" i="1" dirty="0">
                <a:latin typeface="Times New Roman" pitchFamily="18" charset="0"/>
                <a:cs typeface="Times New Roman" pitchFamily="18" charset="0"/>
              </a:rPr>
              <a:t>.</a:t>
            </a:r>
            <a:endParaRPr lang="en-CA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186419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</TotalTime>
  <Words>163</Words>
  <Application>Microsoft Macintosh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shiba</dc:creator>
  <cp:lastModifiedBy>Adriana</cp:lastModifiedBy>
  <cp:revision>21</cp:revision>
  <dcterms:created xsi:type="dcterms:W3CDTF">2013-07-09T00:39:50Z</dcterms:created>
  <dcterms:modified xsi:type="dcterms:W3CDTF">2013-07-09T00:40:00Z</dcterms:modified>
</cp:coreProperties>
</file>